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E5B0DE-5DF0-4ECB-94DD-6B39549DA0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307A27-2046-49BB-AD3F-F5E1BCCA4C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A7AFB0-B22C-45F0-B0FE-F348F936E71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BB242D-786D-4AD6-9327-FE699D1136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1AD0D1-C107-471B-83EF-22D293B7D9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FBD57D-A3E8-4BE2-A689-6A97911C86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F8241-AEBC-47B9-8FE3-3A25C2CF82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BDFAF-7317-4910-B511-C896ECA9C0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18F67D-1A40-4EF3-8783-EE88CA1AAD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37FF07-3496-4F10-B3B5-5AD4DB686D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8AA2E-E94C-46BE-9B3F-752D8D88BA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7105AF-E453-43AF-AA5F-26CA677528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B109BB-6C28-4DFE-B457-F3615AA1C1B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1403280" y="1268280"/>
            <a:ext cx="5977080" cy="3321000"/>
            <a:chOff x="1403280" y="1268280"/>
            <a:chExt cx="5977080" cy="3321000"/>
          </a:xfrm>
        </p:grpSpPr>
        <p:grpSp>
          <p:nvGrpSpPr>
            <p:cNvPr id="42" name="Group 4"/>
            <p:cNvGrpSpPr/>
            <p:nvPr/>
          </p:nvGrpSpPr>
          <p:grpSpPr>
            <a:xfrm>
              <a:off x="1476360" y="1557360"/>
              <a:ext cx="2303640" cy="2232000"/>
              <a:chOff x="1476360" y="1557360"/>
              <a:chExt cx="2303640" cy="2232000"/>
            </a:xfrm>
          </p:grpSpPr>
          <p:sp>
            <p:nvSpPr>
              <p:cNvPr id="43" name="Oval 5"/>
              <p:cNvSpPr/>
              <p:nvPr/>
            </p:nvSpPr>
            <p:spPr>
              <a:xfrm>
                <a:off x="1908000" y="2349360"/>
                <a:ext cx="1440000" cy="1440000"/>
              </a:xfrm>
              <a:prstGeom prst="ellipse">
                <a:avLst/>
              </a:prstGeom>
              <a:noFill/>
              <a:ln w="9360">
                <a:solidFill>
                  <a:srgbClr val="6666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Oval 6"/>
              <p:cNvSpPr/>
              <p:nvPr/>
            </p:nvSpPr>
            <p:spPr>
              <a:xfrm>
                <a:off x="2340000" y="1557360"/>
                <a:ext cx="1440000" cy="1439640"/>
              </a:xfrm>
              <a:prstGeom prst="ellipse">
                <a:avLst/>
              </a:prstGeom>
              <a:noFill/>
              <a:ln w="9360">
                <a:solidFill>
                  <a:srgbClr val="6666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Oval 7"/>
              <p:cNvSpPr/>
              <p:nvPr/>
            </p:nvSpPr>
            <p:spPr>
              <a:xfrm>
                <a:off x="1476360" y="1557360"/>
                <a:ext cx="1440000" cy="1439640"/>
              </a:xfrm>
              <a:prstGeom prst="ellipse">
                <a:avLst/>
              </a:prstGeom>
              <a:noFill/>
              <a:ln w="9360">
                <a:solidFill>
                  <a:srgbClr val="6666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6" name="Group 8"/>
            <p:cNvGrpSpPr/>
            <p:nvPr/>
          </p:nvGrpSpPr>
          <p:grpSpPr>
            <a:xfrm>
              <a:off x="4716360" y="1557360"/>
              <a:ext cx="2303640" cy="2232000"/>
              <a:chOff x="4716360" y="1557360"/>
              <a:chExt cx="2303640" cy="2232000"/>
            </a:xfrm>
          </p:grpSpPr>
          <p:sp>
            <p:nvSpPr>
              <p:cNvPr id="47" name="Oval 9"/>
              <p:cNvSpPr/>
              <p:nvPr/>
            </p:nvSpPr>
            <p:spPr>
              <a:xfrm>
                <a:off x="5148000" y="2349360"/>
                <a:ext cx="1440000" cy="1440000"/>
              </a:xfrm>
              <a:prstGeom prst="ellipse">
                <a:avLst/>
              </a:prstGeom>
              <a:noFill/>
              <a:ln w="9360">
                <a:solidFill>
                  <a:srgbClr val="6666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Oval 10"/>
              <p:cNvSpPr/>
              <p:nvPr/>
            </p:nvSpPr>
            <p:spPr>
              <a:xfrm>
                <a:off x="5580000" y="1557360"/>
                <a:ext cx="1440000" cy="1439640"/>
              </a:xfrm>
              <a:prstGeom prst="ellipse">
                <a:avLst/>
              </a:prstGeom>
              <a:noFill/>
              <a:ln w="9360">
                <a:solidFill>
                  <a:srgbClr val="6666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Oval 11"/>
              <p:cNvSpPr/>
              <p:nvPr/>
            </p:nvSpPr>
            <p:spPr>
              <a:xfrm>
                <a:off x="4716360" y="1557360"/>
                <a:ext cx="1440000" cy="1439640"/>
              </a:xfrm>
              <a:prstGeom prst="ellipse">
                <a:avLst/>
              </a:prstGeom>
              <a:noFill/>
              <a:ln w="9360">
                <a:solidFill>
                  <a:srgbClr val="6666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0" name="Text Box 12"/>
            <p:cNvSpPr/>
            <p:nvPr/>
          </p:nvSpPr>
          <p:spPr>
            <a:xfrm>
              <a:off x="4859280" y="2060640"/>
              <a:ext cx="64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37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3"/>
            <p:cNvSpPr/>
            <p:nvPr/>
          </p:nvSpPr>
          <p:spPr>
            <a:xfrm>
              <a:off x="1619280" y="1989000"/>
              <a:ext cx="64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15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4"/>
            <p:cNvSpPr/>
            <p:nvPr/>
          </p:nvSpPr>
          <p:spPr>
            <a:xfrm>
              <a:off x="2268360" y="1989000"/>
              <a:ext cx="648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2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5"/>
            <p:cNvSpPr/>
            <p:nvPr/>
          </p:nvSpPr>
          <p:spPr>
            <a:xfrm>
              <a:off x="2916360" y="1989000"/>
              <a:ext cx="64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6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6"/>
            <p:cNvSpPr/>
            <p:nvPr/>
          </p:nvSpPr>
          <p:spPr>
            <a:xfrm>
              <a:off x="2268360" y="2421000"/>
              <a:ext cx="648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6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17"/>
            <p:cNvSpPr/>
            <p:nvPr/>
          </p:nvSpPr>
          <p:spPr>
            <a:xfrm>
              <a:off x="1908000" y="2637000"/>
              <a:ext cx="648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5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18"/>
            <p:cNvSpPr/>
            <p:nvPr/>
          </p:nvSpPr>
          <p:spPr>
            <a:xfrm>
              <a:off x="2700360" y="2637000"/>
              <a:ext cx="64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3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19"/>
            <p:cNvSpPr/>
            <p:nvPr/>
          </p:nvSpPr>
          <p:spPr>
            <a:xfrm>
              <a:off x="2268360" y="3141720"/>
              <a:ext cx="648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19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20"/>
            <p:cNvSpPr/>
            <p:nvPr/>
          </p:nvSpPr>
          <p:spPr>
            <a:xfrm>
              <a:off x="5580000" y="1989000"/>
              <a:ext cx="64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21"/>
            <p:cNvSpPr/>
            <p:nvPr/>
          </p:nvSpPr>
          <p:spPr>
            <a:xfrm>
              <a:off x="5580000" y="2421000"/>
              <a:ext cx="64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2"/>
            <p:cNvSpPr/>
            <p:nvPr/>
          </p:nvSpPr>
          <p:spPr>
            <a:xfrm>
              <a:off x="6227640" y="2060640"/>
              <a:ext cx="648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8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23"/>
            <p:cNvSpPr/>
            <p:nvPr/>
          </p:nvSpPr>
          <p:spPr>
            <a:xfrm>
              <a:off x="5219640" y="2565360"/>
              <a:ext cx="64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2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24"/>
            <p:cNvSpPr/>
            <p:nvPr/>
          </p:nvSpPr>
          <p:spPr>
            <a:xfrm>
              <a:off x="5940360" y="2565360"/>
              <a:ext cx="64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25"/>
            <p:cNvSpPr/>
            <p:nvPr/>
          </p:nvSpPr>
          <p:spPr>
            <a:xfrm>
              <a:off x="5580000" y="3124080"/>
              <a:ext cx="64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52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26"/>
            <p:cNvSpPr/>
            <p:nvPr/>
          </p:nvSpPr>
          <p:spPr>
            <a:xfrm>
              <a:off x="1403280" y="1268280"/>
              <a:ext cx="12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TR-PR-Up (29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27"/>
            <p:cNvSpPr/>
            <p:nvPr/>
          </p:nvSpPr>
          <p:spPr>
            <a:xfrm>
              <a:off x="2627280" y="1268280"/>
              <a:ext cx="1584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TL-PL-BL-Up (18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28"/>
            <p:cNvSpPr/>
            <p:nvPr/>
          </p:nvSpPr>
          <p:spPr>
            <a:xfrm>
              <a:off x="2124000" y="3789360"/>
              <a:ext cx="12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BP-Up (351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29"/>
            <p:cNvSpPr/>
            <p:nvPr/>
          </p:nvSpPr>
          <p:spPr>
            <a:xfrm>
              <a:off x="4500720" y="1268280"/>
              <a:ext cx="143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TR-PR-Down (40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30"/>
            <p:cNvSpPr/>
            <p:nvPr/>
          </p:nvSpPr>
          <p:spPr>
            <a:xfrm>
              <a:off x="5867280" y="1268280"/>
              <a:ext cx="1513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TL-PL-BL-Down (9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31"/>
            <p:cNvSpPr/>
            <p:nvPr/>
          </p:nvSpPr>
          <p:spPr>
            <a:xfrm>
              <a:off x="5364000" y="3789360"/>
              <a:ext cx="122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BP-Down (55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32"/>
            <p:cNvSpPr/>
            <p:nvPr/>
          </p:nvSpPr>
          <p:spPr>
            <a:xfrm>
              <a:off x="2124000" y="4221000"/>
              <a:ext cx="935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(A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33"/>
            <p:cNvSpPr/>
            <p:nvPr/>
          </p:nvSpPr>
          <p:spPr>
            <a:xfrm>
              <a:off x="5364000" y="4221000"/>
              <a:ext cx="935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(B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Text Box 2"/>
          <p:cNvSpPr/>
          <p:nvPr/>
        </p:nvSpPr>
        <p:spPr>
          <a:xfrm>
            <a:off x="395280" y="4797360"/>
            <a:ext cx="8280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file 7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. Venn Diagram of all tissue up- (A) and down- (B) regulated DEGs under drought stress.  TR-PR-Up and TR-PR-Down indicate common up- and down-regulated DEGs in root between tillering and panicle elongation stages respectively; TL-PL-BL-Up and TL-PL-BL-Down indicate common up- and down-regulated DEGs in leaves among three developmental stages respectively; BP-Up and  BP-Down indicate shared up- and down-regulated DEGs in panicle at booting stag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15T08:40:07Z</dcterms:created>
  <dc:creator>Binying Fu</dc:creator>
  <dc:description/>
  <dc:language>en-US</dc:language>
  <cp:lastModifiedBy>Binying Fu</cp:lastModifiedBy>
  <dcterms:modified xsi:type="dcterms:W3CDTF">2011-03-09T06:15:08Z</dcterms:modified>
  <cp:revision>5</cp:revision>
  <dc:subject/>
  <dc:title>幻灯片 1</dc:title>
</cp:coreProperties>
</file>